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B94EA7F-9EB8-4470-9FA8-02C5D157A75A}" v="3" dt="2026-03-06T15:59:42.00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874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amimuzzaman, MD - REE-ARS, NE" userId="c4c0c4bf-d3ff-4635-ac06-6d8ad717c455" providerId="ADAL" clId="{5E179223-0B2A-4242-839F-4DB5828EE8F3}"/>
    <pc:docChg chg="custSel addSld modSld">
      <pc:chgData name="Shamimuzzaman, MD - REE-ARS, NE" userId="c4c0c4bf-d3ff-4635-ac06-6d8ad717c455" providerId="ADAL" clId="{5E179223-0B2A-4242-839F-4DB5828EE8F3}" dt="2026-03-06T16:09:20.826" v="239" actId="113"/>
      <pc:docMkLst>
        <pc:docMk/>
      </pc:docMkLst>
      <pc:sldChg chg="addSp delSp modSp new mod">
        <pc:chgData name="Shamimuzzaman, MD - REE-ARS, NE" userId="c4c0c4bf-d3ff-4635-ac06-6d8ad717c455" providerId="ADAL" clId="{5E179223-0B2A-4242-839F-4DB5828EE8F3}" dt="2026-03-06T16:09:20.826" v="239" actId="113"/>
        <pc:sldMkLst>
          <pc:docMk/>
          <pc:sldMk cId="3979581252" sldId="256"/>
        </pc:sldMkLst>
        <pc:spChg chg="del">
          <ac:chgData name="Shamimuzzaman, MD - REE-ARS, NE" userId="c4c0c4bf-d3ff-4635-ac06-6d8ad717c455" providerId="ADAL" clId="{5E179223-0B2A-4242-839F-4DB5828EE8F3}" dt="2026-03-06T15:57:56.064" v="1" actId="478"/>
          <ac:spMkLst>
            <pc:docMk/>
            <pc:sldMk cId="3979581252" sldId="256"/>
            <ac:spMk id="2" creationId="{84C739E6-1F2E-294F-82E5-24CC95881879}"/>
          </ac:spMkLst>
        </pc:spChg>
        <pc:spChg chg="del">
          <ac:chgData name="Shamimuzzaman, MD - REE-ARS, NE" userId="c4c0c4bf-d3ff-4635-ac06-6d8ad717c455" providerId="ADAL" clId="{5E179223-0B2A-4242-839F-4DB5828EE8F3}" dt="2026-03-06T15:57:57.564" v="2" actId="478"/>
          <ac:spMkLst>
            <pc:docMk/>
            <pc:sldMk cId="3979581252" sldId="256"/>
            <ac:spMk id="3" creationId="{7C278681-99C5-EFD3-2109-718B8316C7A8}"/>
          </ac:spMkLst>
        </pc:spChg>
        <pc:spChg chg="add mod">
          <ac:chgData name="Shamimuzzaman, MD - REE-ARS, NE" userId="c4c0c4bf-d3ff-4635-ac06-6d8ad717c455" providerId="ADAL" clId="{5E179223-0B2A-4242-839F-4DB5828EE8F3}" dt="2026-03-06T16:09:20.826" v="239" actId="113"/>
          <ac:spMkLst>
            <pc:docMk/>
            <pc:sldMk cId="3979581252" sldId="256"/>
            <ac:spMk id="6" creationId="{4DEF09EA-9FD8-4D73-03FD-90E937D4083F}"/>
          </ac:spMkLst>
        </pc:spChg>
        <pc:picChg chg="add mod">
          <ac:chgData name="Shamimuzzaman, MD - REE-ARS, NE" userId="c4c0c4bf-d3ff-4635-ac06-6d8ad717c455" providerId="ADAL" clId="{5E179223-0B2A-4242-839F-4DB5828EE8F3}" dt="2026-03-06T15:58:52.945" v="11" actId="1076"/>
          <ac:picMkLst>
            <pc:docMk/>
            <pc:sldMk cId="3979581252" sldId="256"/>
            <ac:picMk id="5" creationId="{68028E68-7967-ADAE-3DFC-239D3E9A3923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B7768F-6F22-AA73-DC94-FBFAFA7657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0F5ED8-A41D-1641-4D82-5EF0C3E21E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B720D3-5679-F2B7-3901-939AB4C14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9F2F1-3200-45EA-AD55-E187C4322550}" type="datetimeFigureOut">
              <a:rPr lang="en-US" smtClean="0"/>
              <a:t>3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7D9505-CEC8-A072-D703-3A3D9AA579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1A3A7E-03F2-051A-AA63-BFE6A8812C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50FC-EDCC-4EBD-92BD-2A6FEFEC4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663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1DE681-E693-1717-7D33-51F88140EC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CACAF6-4027-851E-62CD-9FBC921587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16D607-27FB-435C-65CE-8CF1124D4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9F2F1-3200-45EA-AD55-E187C4322550}" type="datetimeFigureOut">
              <a:rPr lang="en-US" smtClean="0"/>
              <a:t>3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D5E6B1-AA3D-A688-7E47-BFBF50F49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23BDDA-CBF6-73ED-B98E-EC4138EF8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50FC-EDCC-4EBD-92BD-2A6FEFEC4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713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C8C5DDB-4A5E-324D-C313-4A2BEC8685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7C1641-633E-83D7-2320-A479D50895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8088F9-B52D-0419-4EF1-A7288726C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9F2F1-3200-45EA-AD55-E187C4322550}" type="datetimeFigureOut">
              <a:rPr lang="en-US" smtClean="0"/>
              <a:t>3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932D0B-0C1C-263A-D3FD-475B786E06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D9BEC5-1586-6389-D908-FA04E070C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50FC-EDCC-4EBD-92BD-2A6FEFEC4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1657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47BD1F-B4AB-69DB-CAC3-1511F93915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9BB5B9-C1FC-722B-8632-307D7948E3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8C816A-9DBC-D2E0-D253-2E86F0E7D2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9F2F1-3200-45EA-AD55-E187C4322550}" type="datetimeFigureOut">
              <a:rPr lang="en-US" smtClean="0"/>
              <a:t>3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F64724-5828-1457-3471-2A7BB08E0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C10B0F-634A-FBC3-0E1C-A1ADE1ECF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50FC-EDCC-4EBD-92BD-2A6FEFEC4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163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8D752B-21F5-527D-22E0-0A8D0C31D0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3EE8B2-FCEE-4FAC-97E9-F4EBD4742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B26F76-3EEC-1EBD-770E-D793633545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9F2F1-3200-45EA-AD55-E187C4322550}" type="datetimeFigureOut">
              <a:rPr lang="en-US" smtClean="0"/>
              <a:t>3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A87443-A5D2-470C-F802-9122833E9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0314E3-EE9C-A891-C364-256A37AD1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50FC-EDCC-4EBD-92BD-2A6FEFEC4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385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58B145-5287-17BF-2696-289D468B6A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02D305-90A5-0FF1-A19F-028AB518A7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26A7C3-DB6B-A63B-5781-99C2889695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B94BEB-80AA-79D1-0B99-6838E3594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9F2F1-3200-45EA-AD55-E187C4322550}" type="datetimeFigureOut">
              <a:rPr lang="en-US" smtClean="0"/>
              <a:t>3/1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02C81C-C2F1-F5C9-0781-2B08F16C2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76CAF5-374E-35DD-2C4D-E56546C667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50FC-EDCC-4EBD-92BD-2A6FEFEC4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454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E4CB8-3E76-E78B-D540-178169BCDF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EB100C-DA4C-0DC7-0B4F-C11C08D95C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3D8319-6480-096D-FBC1-BFD2A1A6C5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60D9FAB-583E-426D-1579-8DEBBE7887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F12B7B1-0020-3CBB-DFFE-E766F77C24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50A3AB0-5182-450A-FAAE-74A4120431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9F2F1-3200-45EA-AD55-E187C4322550}" type="datetimeFigureOut">
              <a:rPr lang="en-US" smtClean="0"/>
              <a:t>3/11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C856E2-E1BB-BEE9-0DF9-AA9631936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F7430B2-CD77-49A7-F556-45554CAFA2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50FC-EDCC-4EBD-92BD-2A6FEFEC4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775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D7E45F-E66A-CC24-C6A6-83E1BB88E5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70CFADD-A797-EA37-D6C5-1CF39E86F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9F2F1-3200-45EA-AD55-E187C4322550}" type="datetimeFigureOut">
              <a:rPr lang="en-US" smtClean="0"/>
              <a:t>3/11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8201E6-5A05-2EA6-389B-D433A6141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68E501-ACA5-3A31-5B51-94CE0060C9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50FC-EDCC-4EBD-92BD-2A6FEFEC4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313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FDF0137-4315-3897-8A12-9426C33EA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9F2F1-3200-45EA-AD55-E187C4322550}" type="datetimeFigureOut">
              <a:rPr lang="en-US" smtClean="0"/>
              <a:t>3/11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D043A4A-3CA7-63C7-1795-33403C1097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546879-9CBD-D312-5771-33AC18612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50FC-EDCC-4EBD-92BD-2A6FEFEC4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830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569E9A-7441-E626-DC25-3737948AB0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2BE0AE-4E4A-F747-48A6-6C84BA5F08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9CEDFE-C73E-8EDB-5657-89221E9BB6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F960A4-48DE-AE3A-D9B9-0F2C319546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9F2F1-3200-45EA-AD55-E187C4322550}" type="datetimeFigureOut">
              <a:rPr lang="en-US" smtClean="0"/>
              <a:t>3/1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FB3D2E-C3D4-1266-1439-C7E2DBA2F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C87B60-873E-EC5C-C129-7B33CFBB4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50FC-EDCC-4EBD-92BD-2A6FEFEC4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19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CD82AF-08B7-17D4-6606-7858E41481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C5E0F59-D3C2-49D3-C137-93F24DC9A5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D89C08-7E7D-AF61-1B38-FDCC90E43D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285B26-3381-1128-AF3D-27753C4E19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9F2F1-3200-45EA-AD55-E187C4322550}" type="datetimeFigureOut">
              <a:rPr lang="en-US" smtClean="0"/>
              <a:t>3/11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DBF9CF-F916-C217-A228-DB8FEAD674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015519-2489-6E66-2CD1-94A200C8C4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50FC-EDCC-4EBD-92BD-2A6FEFEC4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361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8E74C7A-338E-A8E4-A5A5-FD3DC4DE76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FA8B64-5568-A71B-5557-A75B6DD9D4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8A7323-B760-0863-D78D-6A8223B377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49F2F1-3200-45EA-AD55-E187C4322550}" type="datetimeFigureOut">
              <a:rPr lang="en-US" smtClean="0"/>
              <a:t>3/11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E3A213-1CF5-527D-3D1A-7A53C8722E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25AB27-AB0B-7EC8-AE38-FC1A9FE364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7550FC-EDCC-4EBD-92BD-2A6FEFEC4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983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DEF09EA-9FD8-4D73-03FD-90E937D4083F}"/>
              </a:ext>
            </a:extLst>
          </p:cNvPr>
          <p:cNvSpPr txBox="1"/>
          <p:nvPr/>
        </p:nvSpPr>
        <p:spPr>
          <a:xfrm>
            <a:off x="8081010" y="4892040"/>
            <a:ext cx="305434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ranscription Factor (TF) expression profiles (heat map) of TYLCV infection at 4, 7, 14 and 21 days post-inoculation (DPI). This heatmap was generated using log2foldchange values. The color in the heat map represents gene expression changes (red indicates upregulated TF; green indicates downregulated TF)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9B820D8-40E6-0D25-7CE2-C145421A0A7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0125" y="0"/>
            <a:ext cx="257175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9581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ed5b36e7-01ee-4ebc-867e-e03cfa0d4697}" enabled="0" method="" siteId="{ed5b36e7-01ee-4ebc-867e-e03cfa0d4697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663</TotalTime>
  <Words>6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amimuzzaman, MD - REE-ARS, NE</dc:creator>
  <cp:lastModifiedBy>Kai Shu ling</cp:lastModifiedBy>
  <cp:revision>4</cp:revision>
  <dcterms:created xsi:type="dcterms:W3CDTF">2026-03-06T15:57:50Z</dcterms:created>
  <dcterms:modified xsi:type="dcterms:W3CDTF">2026-03-11T21:53:16Z</dcterms:modified>
</cp:coreProperties>
</file>